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1FF7F8-E2D6-4E24-A5DF-8BCF1B967706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1C98F9-D4B7-4DE9-8684-F3D4263FB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688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80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319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4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71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23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864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013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430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000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05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80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014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4259862" y="855024"/>
          <a:ext cx="2109068" cy="472630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533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2373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aseline="0" dirty="0"/>
                        <a:t>5 weeks</a:t>
                      </a:r>
                      <a:endParaRPr lang="en-US" sz="12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biological proces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 value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hemical synaptic transmiss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5E-08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rvous system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1E-06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axonogenesi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4E-06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gulation of ion transmembrane transpor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7.5E-06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locomotory</a:t>
                      </a:r>
                      <a:r>
                        <a:rPr lang="en-US" sz="1000" u="none" strike="noStrike" baseline="0" dirty="0">
                          <a:effectLst/>
                        </a:rPr>
                        <a:t> behavior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6E-05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brain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7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ell adhes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6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tina layer form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7.4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ulticellular organism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8.4E-05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sitive regulation of action potential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9.4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xon guidanc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0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denylate cyclase-inhibiting GPCR signaling pathwa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5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ell differenti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2E-04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sitive regulation of neuron differenti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2E-04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prepulse</a:t>
                      </a:r>
                      <a:r>
                        <a:rPr lang="en-US" sz="1000" u="none" strike="noStrike" baseline="0" dirty="0">
                          <a:effectLst/>
                        </a:rPr>
                        <a:t> inhibi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2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ngiogenesi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7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gulation of NMDA receptor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7.3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tassium ion transpor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2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synapse assembl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3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eptide hormone processing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4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6583458" y="843294"/>
          <a:ext cx="2132610" cy="515493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08721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23889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aseline="0" dirty="0"/>
                        <a:t>2 weeks</a:t>
                      </a:r>
                      <a:endParaRPr lang="en-US" sz="12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biological proces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 value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ell adhes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3E-11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homophilic</a:t>
                      </a:r>
                      <a:r>
                        <a:rPr lang="en-US" sz="1000" u="none" strike="noStrike" baseline="0" dirty="0">
                          <a:effectLst/>
                        </a:rPr>
                        <a:t> cell adhes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6.6E-11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rvous system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8E-09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transpor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4.8E-09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sitive regulation of excitatory postsynaptic 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4E-07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intracellular protein transpor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6E-07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gulation of ion transmembrane transpor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7E-07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hosphoryl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5.6E-07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transcription, DNA-templated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7.8E-07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phosphoryl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8.2E-07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intracellular signal transduc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2E-06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gative regulation of phosphatase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3E-06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icrotubule cytoskeleton organiz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5.1E-06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gulation of membrane potential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6.4E-06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hythmic proces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2E-05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uron migr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4E-05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uron projection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5E-05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xon guidanc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5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synapse organiz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7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in utero embryonic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2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960572" y="843294"/>
          <a:ext cx="2125806" cy="586930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9417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3162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aseline="0" dirty="0"/>
                        <a:t>2 weeks</a:t>
                      </a:r>
                      <a:endParaRPr lang="en-US" sz="1200" b="1" baseline="0" dirty="0"/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biological proces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p value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homophilic</a:t>
                      </a:r>
                      <a:r>
                        <a:rPr lang="en-US" sz="1000" u="none" strike="noStrike" baseline="0" dirty="0">
                          <a:effectLst/>
                        </a:rPr>
                        <a:t> cell adhesion via plasma membran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5E-1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ell adhes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9.0E-07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intracellular signal transduc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6.5E-06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entral nervous system myelin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1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ctin cytoskeleton organiz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8.1E-05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ho protein signal transduc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9E-04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yelin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4E-04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sitive regulation of myelin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0E-04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actin filament-based movement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7.6E-04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gative regulation of </a:t>
                      </a:r>
                      <a:r>
                        <a:rPr lang="en-US" sz="1000" u="none" strike="noStrike" baseline="0" dirty="0" err="1">
                          <a:effectLst/>
                        </a:rPr>
                        <a:t>macroautophag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1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neural crest cell migration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5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uron projection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7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rvous system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2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ovalent chromatin modific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5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gulation of Rho protein signal transduc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2.5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sitive regulation of stress fiber assembl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5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transcription, DNA-templated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6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 err="1">
                          <a:effectLst/>
                        </a:rPr>
                        <a:t>semaphorin-plexin</a:t>
                      </a:r>
                      <a:r>
                        <a:rPr lang="en-US" sz="1000" u="none" strike="noStrike" baseline="0" dirty="0">
                          <a:effectLst/>
                        </a:rPr>
                        <a:t> signaling pathwa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9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oligodendrocyte differentiation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9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gulation of cell shap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4E-03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8889635" y="855024"/>
          <a:ext cx="2130413" cy="515493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23887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06526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</a:tblGrid>
              <a:tr h="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1" u="none" baseline="0" dirty="0"/>
                        <a:t>5 weeks</a:t>
                      </a:r>
                    </a:p>
                  </a:txBody>
                  <a:tcPr marR="0" marT="0" marB="0"/>
                </a:tc>
                <a:tc hMerge="1">
                  <a:txBody>
                    <a:bodyPr/>
                    <a:lstStyle/>
                    <a:p>
                      <a:endParaRPr lang="en-US" sz="600" b="1" baseline="0" dirty="0"/>
                    </a:p>
                  </a:txBody>
                  <a:tcPr marR="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biological proces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 valu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rotein phosphoryl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3.7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gative regulation of ERK1 and ERK2 cascad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6.4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cell fate commit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7.6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sitive regulation of RNA polymerase II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8.4E-03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alate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0E-02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gulation of </a:t>
                      </a:r>
                      <a:r>
                        <a:rPr lang="en-US" sz="1000" u="none" strike="noStrike" baseline="0" dirty="0" err="1">
                          <a:effectLst/>
                        </a:rPr>
                        <a:t>myotube</a:t>
                      </a:r>
                      <a:r>
                        <a:rPr lang="en-US" sz="1000" u="none" strike="noStrike" baseline="0" dirty="0">
                          <a:effectLst/>
                        </a:rPr>
                        <a:t> differenti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1E-02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gative regulation of protein kinase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3E-02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activation of MAPKKK activity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>
                          <a:effectLst/>
                        </a:rPr>
                        <a:t>1.5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gative regulation of apoptotic proces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1.9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lung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1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>
                          <a:effectLst/>
                        </a:rPr>
                        <a:t>rhythmic process</a:t>
                      </a:r>
                      <a:endParaRPr lang="en-US" sz="1000" b="0" i="0" u="none" strike="noStrike" baseline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3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sitive regulation of apoptotic proces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3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hosphorylation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2.4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positive regulation of p38MAPK cascade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1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rvous system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1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multicellular organism developmen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7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entrainment of circadian clock by photoperiod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8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regulation of sodium ion transport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3.9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negative regulation of RNA polymerase II promoter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2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baseline="0" dirty="0">
                          <a:effectLst/>
                        </a:rPr>
                        <a:t>lung morphogenesis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baseline="0" dirty="0">
                          <a:effectLst/>
                        </a:rPr>
                        <a:t>4.3E-02</a:t>
                      </a:r>
                      <a:endParaRPr lang="en-US" sz="1000" b="0" i="0" u="none" strike="noStrike" baseline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</a:tbl>
          </a:graphicData>
        </a:graphic>
      </p:graphicFrame>
      <p:cxnSp>
        <p:nvCxnSpPr>
          <p:cNvPr id="6" name="Straight Connector 5"/>
          <p:cNvCxnSpPr/>
          <p:nvPr/>
        </p:nvCxnSpPr>
        <p:spPr>
          <a:xfrm>
            <a:off x="8968839" y="1016102"/>
            <a:ext cx="20212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6640198" y="1021269"/>
            <a:ext cx="20212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4341905" y="1016102"/>
            <a:ext cx="20212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2055905" y="1016102"/>
            <a:ext cx="20212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6965AA4B-B240-40D1-B570-7A5D8EB7BD95}"/>
              </a:ext>
            </a:extLst>
          </p:cNvPr>
          <p:cNvSpPr txBox="1"/>
          <p:nvPr/>
        </p:nvSpPr>
        <p:spPr>
          <a:xfrm>
            <a:off x="2026623" y="148276"/>
            <a:ext cx="84497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Table </a:t>
            </a:r>
            <a:r>
              <a:rPr lang="en-US" sz="1400" b="1" smtClean="0"/>
              <a:t>S2. </a:t>
            </a:r>
            <a:r>
              <a:rPr lang="en-US" sz="1400" b="1" dirty="0"/>
              <a:t>Top 20 enriched biological processes of regulated genes in AMY and ACC </a:t>
            </a:r>
            <a:r>
              <a:rPr lang="en-US" sz="1400" b="1" dirty="0">
                <a:solidFill>
                  <a:prstClr val="black"/>
                </a:solidFill>
              </a:rPr>
              <a:t>at 2 and 5 weeks post stress</a:t>
            </a:r>
            <a:r>
              <a:rPr lang="en-US" sz="1400" b="1" dirty="0"/>
              <a:t>.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930555" y="491316"/>
            <a:ext cx="5966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MY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515560" y="491316"/>
            <a:ext cx="5252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CC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2065644" y="790123"/>
            <a:ext cx="42868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6651833" y="783028"/>
            <a:ext cx="42868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2042958" y="6788301"/>
            <a:ext cx="8977090" cy="1389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2067022" y="523860"/>
            <a:ext cx="8977090" cy="1389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2363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97</Words>
  <Application>Microsoft Office PowerPoint</Application>
  <PresentationFormat>Widescreen</PresentationFormat>
  <Paragraphs>1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SU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IEI TANAKA</dc:creator>
  <cp:lastModifiedBy>YUMIN ZHANG</cp:lastModifiedBy>
  <cp:revision>18</cp:revision>
  <dcterms:created xsi:type="dcterms:W3CDTF">2019-03-07T14:38:56Z</dcterms:created>
  <dcterms:modified xsi:type="dcterms:W3CDTF">2019-03-07T22:26:07Z</dcterms:modified>
</cp:coreProperties>
</file>